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1134" y="-208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\SynologyDrive\Dosage%20lignine\acetylbromide-Fabien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\SynologyDrive\Dosage%20lignine\acetylbromide-Fabien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\SynologyDrive\Dosage%20lignine\E400%20lignine%20r&#233;sultats%20(racine)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\SynologyDrive\Dosage%20lignine\Dosage%20acetyl%20bromide%20OE300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\SynologyDrive\Dosage%20lignine\Dosage%20acetyl%20bromide%20OE300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\SynologyDrive\Dosage%20lignine\Dosage%20acetyl%20bromide%20OE300.xlsx" TargetMode="External"/><Relationship Id="rId1" Type="http://schemas.openxmlformats.org/officeDocument/2006/relationships/themeOverride" Target="../theme/themeOverrid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2330868055555556"/>
          <c:y val="6.4675925925925928E-2"/>
          <c:w val="0.72818437499999999"/>
          <c:h val="0.798926851851851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OE!$S$27</c:f>
              <c:strCache>
                <c:ptCount val="1"/>
                <c:pt idx="0">
                  <c:v>lignin (% CWR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OE!$T$28:$T$30</c:f>
                <c:numCache>
                  <c:formatCode>General</c:formatCode>
                  <c:ptCount val="3"/>
                  <c:pt idx="0">
                    <c:v>0.59055016656405013</c:v>
                  </c:pt>
                  <c:pt idx="1">
                    <c:v>0.56060343535489998</c:v>
                  </c:pt>
                  <c:pt idx="2">
                    <c:v>0.49277081814116747</c:v>
                  </c:pt>
                </c:numCache>
              </c:numRef>
            </c:plus>
            <c:minus>
              <c:numRef>
                <c:f>OE!$T$28:$T$30</c:f>
                <c:numCache>
                  <c:formatCode>General</c:formatCode>
                  <c:ptCount val="3"/>
                  <c:pt idx="0">
                    <c:v>0.59055016656405013</c:v>
                  </c:pt>
                  <c:pt idx="1">
                    <c:v>0.56060343535489998</c:v>
                  </c:pt>
                  <c:pt idx="2">
                    <c:v>0.492770818141167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OE!$R$28:$R$30</c:f>
              <c:strCache>
                <c:ptCount val="3"/>
                <c:pt idx="0">
                  <c:v>WT</c:v>
                </c:pt>
                <c:pt idx="1">
                  <c:v>OEAZ2-39</c:v>
                </c:pt>
                <c:pt idx="2">
                  <c:v>OEAZ2-48</c:v>
                </c:pt>
              </c:strCache>
            </c:strRef>
          </c:cat>
          <c:val>
            <c:numRef>
              <c:f>OE!$S$28:$S$30</c:f>
              <c:numCache>
                <c:formatCode>General</c:formatCode>
                <c:ptCount val="3"/>
                <c:pt idx="0">
                  <c:v>22.488158941776469</c:v>
                </c:pt>
                <c:pt idx="1">
                  <c:v>22.395062176931123</c:v>
                </c:pt>
                <c:pt idx="2">
                  <c:v>22.2850628478381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69-419E-84EA-CCB1AB548B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80751360"/>
        <c:axId val="180781824"/>
      </c:barChart>
      <c:catAx>
        <c:axId val="1807513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781824"/>
        <c:crosses val="autoZero"/>
        <c:auto val="1"/>
        <c:lblAlgn val="ctr"/>
        <c:lblOffset val="100"/>
        <c:noMultiLvlLbl val="0"/>
      </c:catAx>
      <c:valAx>
        <c:axId val="18078182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dirty="0"/>
                  <a:t>Wood lignin content</a:t>
                </a:r>
              </a:p>
            </c:rich>
          </c:tx>
          <c:layout>
            <c:manualLayout>
              <c:xMode val="edge"/>
              <c:yMode val="edge"/>
              <c:x val="2.7235470085470087E-2"/>
              <c:y val="0.1056769230769230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807513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2330868055555556"/>
          <c:y val="6.4675925925925928E-2"/>
          <c:w val="0.72818437499999999"/>
          <c:h val="0.798926851851851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OE!$S$1</c:f>
              <c:strCache>
                <c:ptCount val="1"/>
                <c:pt idx="0">
                  <c:v>lignin (% CWR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OE!$T$2:$T$4</c:f>
                <c:numCache>
                  <c:formatCode>General</c:formatCode>
                  <c:ptCount val="3"/>
                  <c:pt idx="0">
                    <c:v>0.67212074497711582</c:v>
                  </c:pt>
                  <c:pt idx="1">
                    <c:v>0.41977578679728278</c:v>
                  </c:pt>
                  <c:pt idx="2">
                    <c:v>0.46280294469623667</c:v>
                  </c:pt>
                </c:numCache>
              </c:numRef>
            </c:plus>
            <c:minus>
              <c:numRef>
                <c:f>OE!$T$2:$T$4</c:f>
                <c:numCache>
                  <c:formatCode>General</c:formatCode>
                  <c:ptCount val="3"/>
                  <c:pt idx="0">
                    <c:v>0.67212074497711582</c:v>
                  </c:pt>
                  <c:pt idx="1">
                    <c:v>0.41977578679728278</c:v>
                  </c:pt>
                  <c:pt idx="2">
                    <c:v>0.462802944696236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OE!$R$2:$R$4</c:f>
              <c:strCache>
                <c:ptCount val="3"/>
                <c:pt idx="0">
                  <c:v>WT</c:v>
                </c:pt>
                <c:pt idx="1">
                  <c:v>OEAZ2-39</c:v>
                </c:pt>
                <c:pt idx="2">
                  <c:v>OEAZ2-48</c:v>
                </c:pt>
              </c:strCache>
            </c:strRef>
          </c:cat>
          <c:val>
            <c:numRef>
              <c:f>OE!$S$2:$S$4</c:f>
              <c:numCache>
                <c:formatCode>General</c:formatCode>
                <c:ptCount val="3"/>
                <c:pt idx="0" formatCode="0.00">
                  <c:v>9.1353856651206691</c:v>
                </c:pt>
                <c:pt idx="1">
                  <c:v>8.4346613977042448</c:v>
                </c:pt>
                <c:pt idx="2">
                  <c:v>7.8864164759404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1A4-4B1D-BDC6-814C718CF2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80880512"/>
        <c:axId val="180882048"/>
      </c:barChart>
      <c:catAx>
        <c:axId val="180880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882048"/>
        <c:crosses val="autoZero"/>
        <c:auto val="1"/>
        <c:lblAlgn val="ctr"/>
        <c:lblOffset val="100"/>
        <c:noMultiLvlLbl val="0"/>
      </c:catAx>
      <c:valAx>
        <c:axId val="18088204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dirty="0"/>
                  <a:t>Bark lignin content</a:t>
                </a:r>
              </a:p>
            </c:rich>
          </c:tx>
          <c:layout>
            <c:manualLayout>
              <c:xMode val="edge"/>
              <c:yMode val="edge"/>
              <c:x val="4.6893055555555556E-2"/>
              <c:y val="0.123309722222222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80880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acines 400'!$K$20</c:f>
              <c:strCache>
                <c:ptCount val="1"/>
                <c:pt idx="0">
                  <c:v>lignin (%CWR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cines 400'!$L$21:$L$23</c:f>
                <c:numCache>
                  <c:formatCode>General</c:formatCode>
                  <c:ptCount val="3"/>
                  <c:pt idx="0">
                    <c:v>1.5628442264197285E-2</c:v>
                  </c:pt>
                  <c:pt idx="1">
                    <c:v>4.6336544364374054E-3</c:v>
                  </c:pt>
                  <c:pt idx="2">
                    <c:v>1.3687055073263529E-2</c:v>
                  </c:pt>
                </c:numCache>
              </c:numRef>
            </c:plus>
            <c:minus>
              <c:numRef>
                <c:f>'racines 400'!$L$21:$L$23</c:f>
                <c:numCache>
                  <c:formatCode>General</c:formatCode>
                  <c:ptCount val="3"/>
                  <c:pt idx="0">
                    <c:v>1.5628442264197285E-2</c:v>
                  </c:pt>
                  <c:pt idx="1">
                    <c:v>4.6336544364374054E-3</c:v>
                  </c:pt>
                  <c:pt idx="2">
                    <c:v>1.368705507326352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cines 400'!$J$21:$J$23</c:f>
              <c:strCache>
                <c:ptCount val="3"/>
                <c:pt idx="0">
                  <c:v>WT</c:v>
                </c:pt>
                <c:pt idx="1">
                  <c:v>OEAZ2-39</c:v>
                </c:pt>
                <c:pt idx="2">
                  <c:v>OEAZ2-48</c:v>
                </c:pt>
              </c:strCache>
            </c:strRef>
          </c:cat>
          <c:val>
            <c:numRef>
              <c:f>'racines 400'!$K$21:$K$23</c:f>
              <c:numCache>
                <c:formatCode>0.00%</c:formatCode>
                <c:ptCount val="3"/>
                <c:pt idx="0">
                  <c:v>0.11650572424091588</c:v>
                </c:pt>
                <c:pt idx="1">
                  <c:v>0.10515679442508712</c:v>
                </c:pt>
                <c:pt idx="2">
                  <c:v>0.121301190099099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6A-42D6-8525-1CA7A197BB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80907008"/>
        <c:axId val="180925184"/>
      </c:barChart>
      <c:catAx>
        <c:axId val="180907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925184"/>
        <c:crosses val="autoZero"/>
        <c:auto val="1"/>
        <c:lblAlgn val="ctr"/>
        <c:lblOffset val="100"/>
        <c:noMultiLvlLbl val="0"/>
      </c:catAx>
      <c:valAx>
        <c:axId val="18092518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b="0" i="0" baseline="0" dirty="0">
                    <a:effectLst/>
                  </a:rPr>
                  <a:t>Root lignin content</a:t>
                </a:r>
                <a:endParaRPr lang="fr-BE" sz="9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2.7235564304461939E-2"/>
              <c:y val="0.1513888888888889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%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809070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4227048611111116"/>
          <c:y val="6.4675925925925928E-2"/>
          <c:w val="0.70922256944444451"/>
          <c:h val="0.798926851851851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wood 300'!$K$1</c:f>
              <c:strCache>
                <c:ptCount val="1"/>
                <c:pt idx="0">
                  <c:v>moyenn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wood 300'!$L$2:$L$5</c:f>
                <c:numCache>
                  <c:formatCode>General</c:formatCode>
                  <c:ptCount val="4"/>
                  <c:pt idx="0">
                    <c:v>1.6223105888605111E-2</c:v>
                  </c:pt>
                  <c:pt idx="1">
                    <c:v>1.070714364662372E-2</c:v>
                  </c:pt>
                  <c:pt idx="2">
                    <c:v>8.8932874250465064E-3</c:v>
                  </c:pt>
                  <c:pt idx="3">
                    <c:v>5.6050575724116746E-3</c:v>
                  </c:pt>
                </c:numCache>
              </c:numRef>
            </c:plus>
            <c:minus>
              <c:numRef>
                <c:f>'wood 300'!$L$2:$L$5</c:f>
                <c:numCache>
                  <c:formatCode>General</c:formatCode>
                  <c:ptCount val="4"/>
                  <c:pt idx="0">
                    <c:v>1.6223105888605111E-2</c:v>
                  </c:pt>
                  <c:pt idx="1">
                    <c:v>1.070714364662372E-2</c:v>
                  </c:pt>
                  <c:pt idx="2">
                    <c:v>8.8932874250465064E-3</c:v>
                  </c:pt>
                  <c:pt idx="3">
                    <c:v>5.605057572411674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ood 300'!$J$2:$J$4</c:f>
              <c:strCache>
                <c:ptCount val="3"/>
                <c:pt idx="0">
                  <c:v>WT</c:v>
                </c:pt>
                <c:pt idx="1">
                  <c:v>OEAZ1-08</c:v>
                </c:pt>
                <c:pt idx="2">
                  <c:v>OEAZ1-13</c:v>
                </c:pt>
              </c:strCache>
            </c:strRef>
          </c:cat>
          <c:val>
            <c:numRef>
              <c:f>'wood 300'!$K$2:$K$4</c:f>
              <c:numCache>
                <c:formatCode>0.00%</c:formatCode>
                <c:ptCount val="3"/>
                <c:pt idx="0">
                  <c:v>0.12944299450549451</c:v>
                </c:pt>
                <c:pt idx="1">
                  <c:v>0.12658516483516485</c:v>
                </c:pt>
                <c:pt idx="2">
                  <c:v>0.111107142857142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4D6-4A88-8FD0-338C37C277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81764864"/>
        <c:axId val="181766400"/>
      </c:barChart>
      <c:catAx>
        <c:axId val="181764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66400"/>
        <c:crosses val="autoZero"/>
        <c:auto val="1"/>
        <c:lblAlgn val="ctr"/>
        <c:lblOffset val="100"/>
        <c:noMultiLvlLbl val="0"/>
      </c:catAx>
      <c:valAx>
        <c:axId val="181766400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Wood</a:t>
                </a:r>
                <a:r>
                  <a:rPr lang="en-US" baseline="0" dirty="0"/>
                  <a:t> </a:t>
                </a:r>
                <a:r>
                  <a:rPr lang="en-US" baseline="0" dirty="0" smtClean="0"/>
                  <a:t>li</a:t>
                </a:r>
                <a:r>
                  <a:rPr lang="en-US" dirty="0" smtClean="0"/>
                  <a:t>gnin </a:t>
                </a:r>
                <a:r>
                  <a:rPr lang="en-US" dirty="0"/>
                  <a:t>content </a:t>
                </a:r>
                <a:r>
                  <a:rPr lang="en-US" baseline="0" dirty="0"/>
                  <a:t> 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2.1808119658119657E-2"/>
              <c:y val="0.1780415954415954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%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81764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4668020833333335"/>
          <c:y val="6.4675925925925928E-2"/>
          <c:w val="0.70481284722222215"/>
          <c:h val="0.798926851851851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ark 300'!$K$1</c:f>
              <c:strCache>
                <c:ptCount val="1"/>
                <c:pt idx="0">
                  <c:v>moyenn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ark 300'!$L$2:$L$5</c:f>
                <c:numCache>
                  <c:formatCode>General</c:formatCode>
                  <c:ptCount val="4"/>
                  <c:pt idx="0">
                    <c:v>6.9251419604628855E-3</c:v>
                  </c:pt>
                  <c:pt idx="1">
                    <c:v>5.1349760614103528E-3</c:v>
                  </c:pt>
                  <c:pt idx="2">
                    <c:v>3.3865236521489679E-3</c:v>
                  </c:pt>
                  <c:pt idx="3">
                    <c:v>3.5654168125841931E-3</c:v>
                  </c:pt>
                </c:numCache>
              </c:numRef>
            </c:plus>
            <c:minus>
              <c:numRef>
                <c:f>'bark 300'!$L$2:$L$5</c:f>
                <c:numCache>
                  <c:formatCode>General</c:formatCode>
                  <c:ptCount val="4"/>
                  <c:pt idx="0">
                    <c:v>6.9251419604628855E-3</c:v>
                  </c:pt>
                  <c:pt idx="1">
                    <c:v>5.1349760614103528E-3</c:v>
                  </c:pt>
                  <c:pt idx="2">
                    <c:v>3.3865236521489679E-3</c:v>
                  </c:pt>
                  <c:pt idx="3">
                    <c:v>3.565416812584193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ark 300'!$J$2:$J$4</c:f>
              <c:strCache>
                <c:ptCount val="3"/>
                <c:pt idx="0">
                  <c:v>WT</c:v>
                </c:pt>
                <c:pt idx="1">
                  <c:v>OEAZ1-08</c:v>
                </c:pt>
                <c:pt idx="2">
                  <c:v>OEAZ1-13</c:v>
                </c:pt>
              </c:strCache>
            </c:strRef>
          </c:cat>
          <c:val>
            <c:numRef>
              <c:f>'bark 300'!$K$2:$K$4</c:f>
              <c:numCache>
                <c:formatCode>0.00%</c:formatCode>
                <c:ptCount val="3"/>
                <c:pt idx="0">
                  <c:v>9.9733516483516471E-2</c:v>
                </c:pt>
                <c:pt idx="1">
                  <c:v>9.0651442307692301E-2</c:v>
                </c:pt>
                <c:pt idx="2">
                  <c:v>9.280219780219779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0D-48D2-8DEA-984D6A2667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81795456"/>
        <c:axId val="181805440"/>
      </c:barChart>
      <c:catAx>
        <c:axId val="1817954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805440"/>
        <c:crosses val="autoZero"/>
        <c:auto val="1"/>
        <c:lblAlgn val="ctr"/>
        <c:lblOffset val="100"/>
        <c:noMultiLvlLbl val="0"/>
      </c:catAx>
      <c:valAx>
        <c:axId val="181805440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Bark lignin content</a:t>
                </a:r>
              </a:p>
            </c:rich>
          </c:tx>
          <c:layout>
            <c:manualLayout>
              <c:xMode val="edge"/>
              <c:yMode val="edge"/>
              <c:x val="2.7235564304461939E-2"/>
              <c:y val="9.1203703703703717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%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817954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4515902777777779"/>
          <c:y val="6.4675925925925928E-2"/>
          <c:w val="0.70633402777777765"/>
          <c:h val="0.798926851851851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oot 300'!$K$1</c:f>
              <c:strCache>
                <c:ptCount val="1"/>
                <c:pt idx="0">
                  <c:v>moyenn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oot 300'!$L$2:$L$4</c:f>
                <c:numCache>
                  <c:formatCode>General</c:formatCode>
                  <c:ptCount val="3"/>
                  <c:pt idx="0">
                    <c:v>6.348881513847539E-3</c:v>
                  </c:pt>
                  <c:pt idx="1">
                    <c:v>6.5435006034941972E-3</c:v>
                  </c:pt>
                  <c:pt idx="2">
                    <c:v>8.7185738855130503E-3</c:v>
                  </c:pt>
                </c:numCache>
              </c:numRef>
            </c:plus>
            <c:minus>
              <c:numRef>
                <c:f>'root 300'!$L$2:$L$4</c:f>
                <c:numCache>
                  <c:formatCode>General</c:formatCode>
                  <c:ptCount val="3"/>
                  <c:pt idx="0">
                    <c:v>6.348881513847539E-3</c:v>
                  </c:pt>
                  <c:pt idx="1">
                    <c:v>6.5435006034941972E-3</c:v>
                  </c:pt>
                  <c:pt idx="2">
                    <c:v>8.718573885513050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oot 300'!$J$2:$J$4</c:f>
              <c:strCache>
                <c:ptCount val="3"/>
                <c:pt idx="0">
                  <c:v>WT</c:v>
                </c:pt>
                <c:pt idx="1">
                  <c:v>OEAZ1-08</c:v>
                </c:pt>
                <c:pt idx="2">
                  <c:v>OEAZ1-13</c:v>
                </c:pt>
              </c:strCache>
            </c:strRef>
          </c:cat>
          <c:val>
            <c:numRef>
              <c:f>'root 300'!$K$2:$K$4</c:f>
              <c:numCache>
                <c:formatCode>0.00%</c:formatCode>
                <c:ptCount val="3"/>
                <c:pt idx="0">
                  <c:v>0.12727335164835163</c:v>
                </c:pt>
                <c:pt idx="1">
                  <c:v>0.139875</c:v>
                </c:pt>
                <c:pt idx="2">
                  <c:v>0.13834409340659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E4-4076-87FF-81320B93B5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81838592"/>
        <c:axId val="181840128"/>
      </c:barChart>
      <c:catAx>
        <c:axId val="1818385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840128"/>
        <c:crosses val="autoZero"/>
        <c:auto val="1"/>
        <c:lblAlgn val="ctr"/>
        <c:lblOffset val="100"/>
        <c:noMultiLvlLbl val="0"/>
      </c:catAx>
      <c:valAx>
        <c:axId val="18184012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Root lignin content </a:t>
                </a:r>
              </a:p>
            </c:rich>
          </c:tx>
          <c:layout>
            <c:manualLayout>
              <c:xMode val="edge"/>
              <c:yMode val="edge"/>
              <c:x val="1.8076923076923074E-2"/>
              <c:y val="0.110199430199430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%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81838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465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742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705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836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984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115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180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854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202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36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350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829004-94A8-455A-9D61-BB91D968EA56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BA889E-AF10-45F1-9E0D-7DE8EE49A73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221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76A187E4-F563-4AC1-8C94-41CE18257981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424647" y="1316525"/>
          <a:ext cx="234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1B25B4FE-C5FA-49C9-8BFA-CD13317C82C3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429000" y="2936525"/>
          <a:ext cx="234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A22F1934-01E1-4BAC-841F-A6C13E72C3CA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432919" y="4752971"/>
          <a:ext cx="234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Graphique 7">
            <a:extLst>
              <a:ext uri="{FF2B5EF4-FFF2-40B4-BE49-F238E27FC236}">
                <a16:creationId xmlns:a16="http://schemas.microsoft.com/office/drawing/2014/main" id="{549D99A0-8A19-4D05-855B-2BD34BDFEF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2219089"/>
              </p:ext>
            </p:extLst>
          </p:nvPr>
        </p:nvGraphicFramePr>
        <p:xfrm>
          <a:off x="1089000" y="1316525"/>
          <a:ext cx="234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Graphique 8">
            <a:extLst>
              <a:ext uri="{FF2B5EF4-FFF2-40B4-BE49-F238E27FC236}">
                <a16:creationId xmlns:a16="http://schemas.microsoft.com/office/drawing/2014/main" id="{2BE7A719-FEC2-49A8-A375-77026371C1BF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084647" y="2936525"/>
          <a:ext cx="234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1" name="Graphique 10">
            <a:extLst>
              <a:ext uri="{FF2B5EF4-FFF2-40B4-BE49-F238E27FC236}">
                <a16:creationId xmlns:a16="http://schemas.microsoft.com/office/drawing/2014/main" id="{20578904-DB8E-481B-872E-E7D13011B080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092919" y="4702386"/>
          <a:ext cx="234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ZoneTexte 9">
            <a:extLst>
              <a:ext uri="{FF2B5EF4-FFF2-40B4-BE49-F238E27FC236}">
                <a16:creationId xmlns:a16="http://schemas.microsoft.com/office/drawing/2014/main" id="{8EF32664-F9AB-44E8-B04D-2BEFA5BC73A8}"/>
              </a:ext>
            </a:extLst>
          </p:cNvPr>
          <p:cNvSpPr txBox="1"/>
          <p:nvPr/>
        </p:nvSpPr>
        <p:spPr>
          <a:xfrm>
            <a:off x="878174" y="6706280"/>
            <a:ext cx="535086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just">
              <a:defRPr sz="1200" b="1">
                <a:latin typeface="+mj-lt"/>
                <a:ea typeface="+mj-ea"/>
                <a:cs typeface="+mj-cs"/>
              </a:defRPr>
            </a:lvl1pPr>
          </a:lstStyle>
          <a:p>
            <a:pPr defTabSz="371484">
              <a:defRPr/>
            </a:pP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gnin content (% CWR ± SE) in different tissues of </a:t>
            </a:r>
            <a:r>
              <a:rPr lang="en-US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m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th-old WT, 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S-UGT72AZ1 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S-UGT72AZ2 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nes grown in the greenhouse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(a-d) 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 of the stem (</a:t>
            </a:r>
            <a:r>
              <a:rPr lang="en-US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 cm in the base of the stem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e-f) 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. 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,c,e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35S-UGT7AZ1 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WT. 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,d,f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35S-UGT72AZ2 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WT. 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-b) 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od. 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-d) 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rk. Analyses were made by 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sing the 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etyl bromide method (n = 3-7). There was not significant differences between the WT and the transgenic lines, as determined with a Student’s </a:t>
            </a:r>
            <a:r>
              <a:rPr lang="en-US" b="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-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st 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 0,05). </a:t>
            </a:r>
          </a:p>
          <a:p>
            <a:pPr defTabSz="371484">
              <a:defRPr/>
            </a:pPr>
            <a:endParaRPr 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4C20C692-29D7-48B5-87F2-43CAA2BB0A41}"/>
              </a:ext>
            </a:extLst>
          </p:cNvPr>
          <p:cNvSpPr txBox="1"/>
          <p:nvPr/>
        </p:nvSpPr>
        <p:spPr>
          <a:xfrm>
            <a:off x="1021905" y="1223677"/>
            <a:ext cx="392113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463" dirty="0"/>
              <a:t>(a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A54899B9-5DAE-4A4A-A84A-D88226EB034E}"/>
              </a:ext>
            </a:extLst>
          </p:cNvPr>
          <p:cNvSpPr txBox="1"/>
          <p:nvPr/>
        </p:nvSpPr>
        <p:spPr>
          <a:xfrm>
            <a:off x="3357551" y="1223677"/>
            <a:ext cx="392113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463" dirty="0"/>
              <a:t>(b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4BDF2021-4797-48C0-BC88-49ED63560602}"/>
              </a:ext>
            </a:extLst>
          </p:cNvPr>
          <p:cNvSpPr txBox="1"/>
          <p:nvPr/>
        </p:nvSpPr>
        <p:spPr>
          <a:xfrm>
            <a:off x="1021905" y="2845675"/>
            <a:ext cx="392113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463" dirty="0"/>
              <a:t>(c)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DA9C9BAC-016D-48EC-8956-D139E9ECEC1B}"/>
              </a:ext>
            </a:extLst>
          </p:cNvPr>
          <p:cNvSpPr txBox="1"/>
          <p:nvPr/>
        </p:nvSpPr>
        <p:spPr>
          <a:xfrm>
            <a:off x="3357551" y="2843677"/>
            <a:ext cx="392113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463" dirty="0"/>
              <a:t>(d)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594D43C9-6659-48E8-8D2E-139345FC9A0C}"/>
              </a:ext>
            </a:extLst>
          </p:cNvPr>
          <p:cNvSpPr txBox="1"/>
          <p:nvPr/>
        </p:nvSpPr>
        <p:spPr>
          <a:xfrm>
            <a:off x="1021905" y="4592961"/>
            <a:ext cx="392113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463" dirty="0"/>
              <a:t>(e)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48604252-CD41-477D-9FDE-4ED01DAAB52E}"/>
              </a:ext>
            </a:extLst>
          </p:cNvPr>
          <p:cNvSpPr txBox="1"/>
          <p:nvPr/>
        </p:nvSpPr>
        <p:spPr>
          <a:xfrm>
            <a:off x="3357551" y="4592961"/>
            <a:ext cx="392113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463" dirty="0"/>
              <a:t>(f)</a:t>
            </a:r>
          </a:p>
        </p:txBody>
      </p:sp>
    </p:spTree>
    <p:extLst>
      <p:ext uri="{BB962C8B-B14F-4D97-AF65-F5344CB8AC3E}">
        <p14:creationId xmlns:p14="http://schemas.microsoft.com/office/powerpoint/2010/main" val="38835944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47</Words>
  <Application>Microsoft Office PowerPoint</Application>
  <PresentationFormat>Format A4 (210 x 297 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 baucher</dc:creator>
  <cp:lastModifiedBy>marie baucher</cp:lastModifiedBy>
  <cp:revision>5</cp:revision>
  <dcterms:created xsi:type="dcterms:W3CDTF">2020-05-22T14:54:32Z</dcterms:created>
  <dcterms:modified xsi:type="dcterms:W3CDTF">2020-06-25T07:20:13Z</dcterms:modified>
</cp:coreProperties>
</file>